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0" r:id="rId4"/>
    <p:sldId id="258" r:id="rId5"/>
    <p:sldId id="259" r:id="rId6"/>
    <p:sldId id="261" r:id="rId7"/>
  </p:sldIdLst>
  <p:sldSz cx="73152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63" autoAdjust="0"/>
    <p:restoredTop sz="94660"/>
  </p:normalViewPr>
  <p:slideViewPr>
    <p:cSldViewPr snapToGrid="0">
      <p:cViewPr>
        <p:scale>
          <a:sx n="82" d="100"/>
          <a:sy n="82" d="100"/>
        </p:scale>
        <p:origin x="1548" y="-4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496484"/>
            <a:ext cx="6217920" cy="31834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02717"/>
            <a:ext cx="5486400" cy="2207683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759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424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86834"/>
            <a:ext cx="157734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86834"/>
            <a:ext cx="4640580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939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020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279653"/>
            <a:ext cx="6309360" cy="380364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119286"/>
            <a:ext cx="6309360" cy="2000249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451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772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86836"/>
            <a:ext cx="630936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41551"/>
            <a:ext cx="3094672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340100"/>
            <a:ext cx="3094672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41551"/>
            <a:ext cx="3109913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340100"/>
            <a:ext cx="310991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249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667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213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16569"/>
            <a:ext cx="3703320" cy="6498167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358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16569"/>
            <a:ext cx="3703320" cy="6498167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277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34167"/>
            <a:ext cx="630936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092A20-8ADB-4252-A554-D23C3DB37A0D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1C6174-FA6B-406E-8CE1-F33871BE4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196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405" y="1931414"/>
            <a:ext cx="6764390" cy="5281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72081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483326" y="376731"/>
            <a:ext cx="4747981" cy="7560727"/>
            <a:chOff x="483326" y="1374267"/>
            <a:chExt cx="4747981" cy="756072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r="39289" b="21097"/>
            <a:stretch/>
          </p:blipFill>
          <p:spPr>
            <a:xfrm>
              <a:off x="708156" y="1374267"/>
              <a:ext cx="3916095" cy="5000407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7310" y="6630536"/>
              <a:ext cx="4523997" cy="2304458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483326" y="6374674"/>
              <a:ext cx="7968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 Rounded MT Bold" panose="020F0704030504030204" pitchFamily="34" charset="0"/>
                </a:rPr>
                <a:t>C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228600" y="7937458"/>
            <a:ext cx="6712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2. </a:t>
            </a:r>
          </a:p>
        </p:txBody>
      </p:sp>
    </p:spTree>
    <p:extLst>
      <p:ext uri="{BB962C8B-B14F-4D97-AF65-F5344CB8AC3E}">
        <p14:creationId xmlns:p14="http://schemas.microsoft.com/office/powerpoint/2010/main" val="42162694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5475" y="2759273"/>
            <a:ext cx="5984250" cy="36254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73548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7377" y="135392"/>
            <a:ext cx="4537075" cy="4310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sp>
        <p:nvSpPr>
          <p:cNvPr id="2" name="Text Box 3"/>
          <p:cNvSpPr txBox="1">
            <a:spLocks noChangeArrowheads="1"/>
          </p:cNvSpPr>
          <p:nvPr/>
        </p:nvSpPr>
        <p:spPr bwMode="auto">
          <a:xfrm>
            <a:off x="828902" y="4824867"/>
            <a:ext cx="5997575" cy="1196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l Figure S4.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RhoGDI2 mRNA expression levels were assessed in breast tumors (all subtypes) using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ublically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vailable breast cancer expression array datasets and Km Plotter software (kmplot.org).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ffymetrix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robe 1555812_a_at (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RHGDIB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/RhoGDI2) in breast cancer samples (N = 1660) was used. Samples were separated at the median level RhoGDI2/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RHGDIB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expression, and plotted against metastasis-free survival for each sample in the shown Kaplan-Meier curve.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46999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520697" y="3969882"/>
            <a:ext cx="5995988" cy="1730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l Figure S5. 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IAM1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mRNA expression levels were assessed in breast tumors (all subtypes) using publicly available breast cancer expression array datasets and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Bio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software (cbio.org).  The METABRIC data set (N = 2509) was used. Samples with 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IAM1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expression &gt; 1.5 S.D. from the mean for all tumors in the group, combined with tumors gene amplified for 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IAM1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(for a total of 6% of the 2509 tumors) were plotted against overall survival for each sample in the shown Kaplan-Meier curve. Log-rank test for statistical significance was calculated by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Bio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software.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209" y="-3175"/>
            <a:ext cx="6411913" cy="3903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184280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0492" y="986089"/>
            <a:ext cx="4566677" cy="27405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-287438" y="2117911"/>
            <a:ext cx="224068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 Rounded MT Bold" panose="020F0704030504030204" pitchFamily="34" charset="0"/>
              </a:rPr>
              <a:t>Number of cells migrating</a:t>
            </a:r>
          </a:p>
        </p:txBody>
      </p:sp>
      <p:cxnSp>
        <p:nvCxnSpPr>
          <p:cNvPr id="6" name="Straight Connector 5"/>
          <p:cNvCxnSpPr/>
          <p:nvPr/>
        </p:nvCxnSpPr>
        <p:spPr>
          <a:xfrm>
            <a:off x="2090057" y="1551218"/>
            <a:ext cx="1012371" cy="0"/>
          </a:xfrm>
          <a:prstGeom prst="line">
            <a:avLst/>
          </a:prstGeom>
          <a:ln w="28575" cap="sq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75315" y="2258790"/>
            <a:ext cx="1012371" cy="0"/>
          </a:xfrm>
          <a:prstGeom prst="line">
            <a:avLst/>
          </a:prstGeom>
          <a:ln w="28575" cap="sq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220686" y="1306288"/>
            <a:ext cx="718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Rounded MT Bold" panose="020F0704030504030204" pitchFamily="34" charset="0"/>
              </a:rPr>
              <a:t>P = </a:t>
            </a:r>
            <a:r>
              <a:rPr lang="en-US" sz="1200" dirty="0" err="1">
                <a:latin typeface="Arial Rounded MT Bold" panose="020F0704030504030204" pitchFamily="34" charset="0"/>
              </a:rPr>
              <a:t>n.s</a:t>
            </a:r>
            <a:r>
              <a:rPr lang="en-US" sz="1200" dirty="0">
                <a:latin typeface="Arial Rounded MT Bold" panose="020F0704030504030204" pitchFamily="34" charset="0"/>
              </a:rPr>
              <a:t>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022106" y="1981791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Rounded MT Bold" panose="020F0704030504030204" pitchFamily="34" charset="0"/>
              </a:rPr>
              <a:t>P &lt; 0.001</a:t>
            </a:r>
          </a:p>
        </p:txBody>
      </p:sp>
      <p:sp>
        <p:nvSpPr>
          <p:cNvPr id="10" name="Text Box 2"/>
          <p:cNvSpPr txBox="1">
            <a:spLocks noChangeArrowheads="1"/>
          </p:cNvSpPr>
          <p:nvPr/>
        </p:nvSpPr>
        <p:spPr bwMode="auto">
          <a:xfrm>
            <a:off x="520697" y="3969882"/>
            <a:ext cx="5995988" cy="1730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l Figure S6. 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KBR3 cells expressing 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hScr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or 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hRictor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were transduced with 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d.RFP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or with 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d.AktDD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</a:t>
            </a:r>
            <a:r>
              <a:rPr lang="en-US" altLang="en-US" sz="11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Cells were seeded in the upper chambers of </a:t>
            </a:r>
            <a:r>
              <a:rPr lang="en-US" altLang="en-US" sz="1100" i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ranswell</a:t>
            </a:r>
            <a:r>
              <a:rPr lang="en-US" altLang="en-US" sz="11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 inserts, and the number of cells reaching the bottom side of the insert was measured on crystal violet-stained filters 24 h after seeding. Student’s T-test was used to assess significance. N = 4.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8574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279</Words>
  <Application>Microsoft Office PowerPoint</Application>
  <PresentationFormat>Custom</PresentationFormat>
  <Paragraphs>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Arial Rounded MT Bold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cook</dc:creator>
  <cp:lastModifiedBy>rebecca cook</cp:lastModifiedBy>
  <cp:revision>3</cp:revision>
  <dcterms:created xsi:type="dcterms:W3CDTF">2017-05-16T22:28:13Z</dcterms:created>
  <dcterms:modified xsi:type="dcterms:W3CDTF">2017-05-18T19:48:46Z</dcterms:modified>
</cp:coreProperties>
</file>